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5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D34E35-15AB-4C32-AF8E-C0B46B7667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E4669A4-A63E-4711-9756-A167731963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99CD25-90F8-45C9-A723-B801FE1E6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A79815-95A1-45B5-9705-123CEB135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4F86A2-7E4F-47ED-B27F-366847B17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628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37D1DA-8F93-4E91-89CD-7603436B5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9BC591-8C1D-49CF-8D1A-4801A9CAB0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648587-0AB8-46E6-BBE5-B5A5296D4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34A3B3-0BB6-4033-A85C-6827DE507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EC5E57-8CED-4EB3-9CB8-68804B9AF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796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609BFD1-7E32-4038-9974-88AA3AA0A8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9BA4A9-09EB-4FD2-B48A-349111D9F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4B7730-A805-43DA-93A0-BA7CE108F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51C50B-199C-4AE7-A4DB-8BA36D1FD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511A0B-096A-4F51-BFE5-730603793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200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1F8392-0AC5-43D8-B2B1-C827FB868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6C2155-5458-4D9A-AAF0-4FC8975AAF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7F3B46-C383-48D6-8F60-811A4AD5E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78E8DA-B96F-4152-AEC8-B5D427E15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A7926A-6E76-4705-A279-62FE0EA85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164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389B40-03AF-416A-A57C-FEA114061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C645205-F0D4-41C2-83B1-77864C810D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1D2E51-1AAA-4577-9843-BFA796719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6C24A1-87BC-4370-9166-5E5287084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7D679A-C820-402A-9DD3-D620E4C1A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87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9CB12D-3770-40D1-B231-EAD9F8D19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1077DD-5903-484A-B81B-39C09C792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788139-E693-487A-8CE4-C8E0AEE7C9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DDA3BC3-F7FD-4721-B993-C449F8749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9CB34B-BCE7-4323-8CA3-7596ED594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B2FF279-D435-4041-A711-09F62B8A9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2179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085F48-6D82-444A-9588-79B959E12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430470-A218-4AF4-976E-0DBF174252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85842FA-FAE5-49C7-847A-53F8FFBC89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1E4F4C1-4D4D-4C6B-AF9A-7D13ECB43F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CEFA48-309A-4EA6-88D0-E8BD3BDB8F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408A367-1143-4DCB-AA11-6BB0AD140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4B0324A-FAA1-455E-8B94-B8043FAB9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D3E76E1-AFE6-4D42-8097-5E3EF652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1824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8FE376-FBD9-4A8E-B80A-0E9E78A27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F355370-82BF-4A20-B793-11D7BB9E1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9DBCFB4-C28C-47CA-AC3B-8CFA252E8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907367C-2882-4AC6-88BD-41A04E0B6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6134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515D373-DF08-417F-BC96-5BF304260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558D25C-AD04-458B-8660-61EBF6A5E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9114526-82A8-45EE-B609-F4A9934F7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351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653DC7-CDA0-433A-A293-E4B75B753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0533A9-9E39-48A4-B161-F66E2B245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02C7698-93CB-4D2E-9322-A1898EC337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4849BC2-F436-4776-8949-8D61000C7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8642335-033A-4E12-B513-55A91144F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A4FF5B1-66AC-45C5-B890-591442342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611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EB8601-48E5-4114-A329-A2D3EC70F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70C32FE-C568-4620-A580-1B5C507DDA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80A11D6-0240-424D-B582-708E3A1499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8B7F52-56F6-4CAA-BCD9-BB12A0F06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BE1DEF-EB7E-49BE-BB93-94928EBFB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BE4CC66-0CCD-4104-AA05-81ABC50C9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31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8BEE8BB-CE27-4A4F-ADCD-7E62FA8DA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4FE0AE6-0D41-48A0-A4DE-19409BBF3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A413D1-DFDC-49D9-9EDC-6ECC2661B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A350A-5359-473B-A17C-B8F6F4B748EA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9061CA-4473-4475-8EE8-1BF983E2AF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66BFC6-3EC6-4195-AA6F-A8A85FA4F8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FACE0-C921-4635-B5CA-FCDF4EEDEA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706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5366D87-116A-4D87-ACBA-6CFD2BB82160}"/>
              </a:ext>
            </a:extLst>
          </p:cNvPr>
          <p:cNvSpPr txBox="1"/>
          <p:nvPr/>
        </p:nvSpPr>
        <p:spPr>
          <a:xfrm>
            <a:off x="-1873623" y="134471"/>
            <a:ext cx="9538447" cy="3570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ble 2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haracteristics of patients in the early recurrence and non-early recurrence groups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38D66C6-AFB0-49A9-BCAD-BB65EA68BE13}"/>
              </a:ext>
            </a:extLst>
          </p:cNvPr>
          <p:cNvSpPr txBox="1"/>
          <p:nvPr/>
        </p:nvSpPr>
        <p:spPr>
          <a:xfrm>
            <a:off x="2231512" y="6026415"/>
            <a:ext cx="8105494" cy="6801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PS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odified Glasgow Prognostic Score; NLR: neutrophil-to-lymphocyte ratio; PLR: platelet-to-lymphocyte ratio; PNI: prognostic nutritional index; BMI: body mass index; PMI: psoas muscle mass index; CA19-9: carbohydrate antigen 19-9; CRP: C-reactive protein; IQR: interquartile range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2296CE9F-A494-48EC-AB79-0126F7259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4612221"/>
              </p:ext>
            </p:extLst>
          </p:nvPr>
        </p:nvGraphicFramePr>
        <p:xfrm>
          <a:off x="1924424" y="725301"/>
          <a:ext cx="8128000" cy="520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Worksheet" r:id="rId3" imgW="13677931" imgH="8762778" progId="Excel.Sheet.12">
                  <p:embed/>
                </p:oleObj>
              </mc:Choice>
              <mc:Fallback>
                <p:oleObj name="Worksheet" r:id="rId3" imgW="13677931" imgH="87627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24424" y="725301"/>
                        <a:ext cx="8128000" cy="520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01366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5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Microsoft Excel ワークシー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梅澤 早織</dc:creator>
  <cp:lastModifiedBy>梅澤 早織</cp:lastModifiedBy>
  <cp:revision>2</cp:revision>
  <dcterms:created xsi:type="dcterms:W3CDTF">2022-03-27T03:39:59Z</dcterms:created>
  <dcterms:modified xsi:type="dcterms:W3CDTF">2022-03-27T03:45:01Z</dcterms:modified>
</cp:coreProperties>
</file>